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438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61726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38980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4415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32956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908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37082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1265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34665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048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6056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9458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54BF6-7690-465D-A354-4BD9D5EAB682}" type="datetimeFigureOut">
              <a:rPr kumimoji="1" lang="ja-JP" altLang="en-US" smtClean="0"/>
              <a:t>2019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B5C1B4-F5F5-479C-BC50-8DA97BDF004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84569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504" y="633076"/>
            <a:ext cx="2952328" cy="2344936"/>
          </a:xfrm>
          <a:prstGeom prst="rect">
            <a:avLst/>
          </a:prstGeom>
        </p:spPr>
      </p:pic>
      <p:pic>
        <p:nvPicPr>
          <p:cNvPr id="5" name="図 4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15740" y="633076"/>
            <a:ext cx="2806452" cy="2344936"/>
          </a:xfrm>
          <a:prstGeom prst="rect">
            <a:avLst/>
          </a:prstGeom>
        </p:spPr>
      </p:pic>
      <p:pic>
        <p:nvPicPr>
          <p:cNvPr id="6" name="図 5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8144" y="633076"/>
            <a:ext cx="2845668" cy="2334240"/>
          </a:xfrm>
          <a:prstGeom prst="rect">
            <a:avLst/>
          </a:prstGeom>
        </p:spPr>
      </p:pic>
      <p:pic>
        <p:nvPicPr>
          <p:cNvPr id="7" name="図 6"/>
          <p:cNvPicPr>
            <a:picLocks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112" y="3501008"/>
            <a:ext cx="2952328" cy="2272928"/>
          </a:xfrm>
          <a:prstGeom prst="rect">
            <a:avLst/>
          </a:prstGeom>
        </p:spPr>
      </p:pic>
      <p:pic>
        <p:nvPicPr>
          <p:cNvPr id="8" name="図 7"/>
          <p:cNvPicPr>
            <a:picLocks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3252" y="3515504"/>
            <a:ext cx="2839300" cy="2274808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>
            <a:off x="579984" y="1016804"/>
            <a:ext cx="17107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A) 100% G145A</a:t>
            </a:r>
            <a:endParaRPr kumimoji="1" lang="ja-JP" altLang="en-US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635896" y="1016804"/>
            <a:ext cx="15856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B) 50% G145A</a:t>
            </a:r>
            <a:endParaRPr kumimoji="1" lang="ja-JP" altLang="en-US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6660232" y="1027768"/>
            <a:ext cx="15311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C) 25%G145A</a:t>
            </a:r>
            <a:endParaRPr kumimoji="1" lang="ja-JP" altLang="en-US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97668" y="3861048"/>
            <a:ext cx="1550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D) 10%G145A</a:t>
            </a:r>
            <a:endParaRPr kumimoji="1" lang="ja-JP" altLang="en-US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638340" y="3873798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(E) 1%G145A</a:t>
            </a:r>
            <a:endParaRPr kumimoji="1" lang="ja-JP" altLang="en-US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97928" y="138613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606317" y="1940614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90292" y="1509247"/>
            <a:ext cx="12250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010999" y="1447691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061179" y="2246675"/>
            <a:ext cx="8789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6820532" y="1447691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8078194" y="1755089"/>
            <a:ext cx="950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/>
          <p:cNvCxnSpPr/>
          <p:nvPr/>
        </p:nvCxnSpPr>
        <p:spPr>
          <a:xfrm>
            <a:off x="1185161" y="2186834"/>
            <a:ext cx="0" cy="30606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/>
          <p:cNvCxnSpPr>
            <a:stCxn id="16" idx="3"/>
          </p:cNvCxnSpPr>
          <p:nvPr/>
        </p:nvCxnSpPr>
        <p:spPr>
          <a:xfrm>
            <a:off x="1915307" y="1632358"/>
            <a:ext cx="179887" cy="292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線矢印コネクタ 26"/>
          <p:cNvCxnSpPr/>
          <p:nvPr/>
        </p:nvCxnSpPr>
        <p:spPr>
          <a:xfrm>
            <a:off x="5061179" y="1661646"/>
            <a:ext cx="107509" cy="1438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線矢印コネクタ 28"/>
          <p:cNvCxnSpPr/>
          <p:nvPr/>
        </p:nvCxnSpPr>
        <p:spPr>
          <a:xfrm flipV="1">
            <a:off x="5500665" y="2063723"/>
            <a:ext cx="0" cy="182952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8388424" y="2155199"/>
            <a:ext cx="0" cy="1846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テキスト ボックス 31"/>
          <p:cNvSpPr txBox="1"/>
          <p:nvPr/>
        </p:nvSpPr>
        <p:spPr>
          <a:xfrm>
            <a:off x="782659" y="4391251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2040321" y="4698649"/>
            <a:ext cx="950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直線矢印コネクタ 33"/>
          <p:cNvCxnSpPr/>
          <p:nvPr/>
        </p:nvCxnSpPr>
        <p:spPr>
          <a:xfrm>
            <a:off x="2350551" y="5098759"/>
            <a:ext cx="0" cy="1846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3830013" y="4406687"/>
            <a:ext cx="11576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ild-type probe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/>
          <p:cNvSpPr txBox="1"/>
          <p:nvPr/>
        </p:nvSpPr>
        <p:spPr>
          <a:xfrm>
            <a:off x="5061414" y="4757082"/>
            <a:ext cx="95074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G145A-type probe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直線矢印コネクタ 36"/>
          <p:cNvCxnSpPr/>
          <p:nvPr/>
        </p:nvCxnSpPr>
        <p:spPr>
          <a:xfrm>
            <a:off x="5328861" y="5141597"/>
            <a:ext cx="0" cy="18466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線矢印コネクタ 39"/>
          <p:cNvCxnSpPr/>
          <p:nvPr/>
        </p:nvCxnSpPr>
        <p:spPr>
          <a:xfrm>
            <a:off x="7812360" y="1670148"/>
            <a:ext cx="107509" cy="1438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矢印コネクタ 40"/>
          <p:cNvCxnSpPr/>
          <p:nvPr/>
        </p:nvCxnSpPr>
        <p:spPr>
          <a:xfrm>
            <a:off x="4864903" y="4619358"/>
            <a:ext cx="107509" cy="1438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線矢印コネクタ 41"/>
          <p:cNvCxnSpPr/>
          <p:nvPr/>
        </p:nvCxnSpPr>
        <p:spPr>
          <a:xfrm>
            <a:off x="1815653" y="4619358"/>
            <a:ext cx="107509" cy="14389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32300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</TotalTime>
  <Words>44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uki</dc:creator>
  <cp:lastModifiedBy>Haruki</cp:lastModifiedBy>
  <cp:revision>2</cp:revision>
  <dcterms:created xsi:type="dcterms:W3CDTF">2019-10-25T23:27:53Z</dcterms:created>
  <dcterms:modified xsi:type="dcterms:W3CDTF">2019-10-25T23:58:20Z</dcterms:modified>
</cp:coreProperties>
</file>